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10080625" cy="7559675"/>
  <p:notesSz cx="7559675" cy="10691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7F0CF5-9CD1-4C89-9758-0C7537EEDBB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7092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4000"/>
            <a:ext cx="907092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96C4BB-4720-4DEF-910C-C49AE23D9F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124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D083B-95C3-4836-AE3F-FF1EEBA450B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70120" y="176832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6960" y="176832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400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70120" y="437400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6960" y="437400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8DE233-AE57-4A83-BB93-854E45E1C0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7092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4D0F53-7383-4582-AE59-98565AE9B6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7092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6DE38-24A9-4710-B768-0EEDB6D3B7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974223-6778-47DC-A748-6F9598F0ABB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BCF0C0-D91E-463F-AA42-9B1BD0115C7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7092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E72F4D-73EB-474A-901E-AE5BE55A02B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8BD185-6912-4DF3-9D3E-0E2E33B50B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124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F2C4DF8-CE68-4239-ABC0-C257DF1D6A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907092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3000"/>
              </a:lnSpc>
              <a:spcAft>
                <a:spcPts val="1426"/>
              </a:spcAft>
              <a:buNone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392A48-61E4-4799-A9A8-3958CEF5A3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3000"/>
              </a:lnSpc>
              <a:buNone/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7092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431640" indent="-32364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863640" indent="-28728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295280" indent="-21564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727280" indent="-21600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158920" indent="-21564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158920" indent="-21564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158920" indent="-215640">
              <a:lnSpc>
                <a:spcPct val="93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080"/>
            <a:ext cx="2346120" cy="5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080"/>
            <a:ext cx="3193920" cy="5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ct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6280" y="6886080"/>
            <a:ext cx="2346480" cy="5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95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fld id="{48137ACE-ACAD-4CB4-AC50-47E510702C8A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427640" y="4356000"/>
            <a:ext cx="4968720" cy="2592360"/>
          </a:xfrm>
          <a:prstGeom prst="rect">
            <a:avLst/>
          </a:prstGeom>
          <a:solidFill>
            <a:srgbClr val="edfa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020000" y="3079800"/>
            <a:ext cx="1081080" cy="160200"/>
          </a:xfrm>
          <a:prstGeom prst="rect">
            <a:avLst/>
          </a:prstGeom>
          <a:solidFill>
            <a:srgbClr val="00ae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2700360" y="3527280"/>
            <a:ext cx="1081080" cy="144720"/>
          </a:xfrm>
          <a:prstGeom prst="rect">
            <a:avLst/>
          </a:prstGeom>
          <a:solidFill>
            <a:srgbClr val="9966cc"/>
          </a:solidFill>
          <a:ln w="9360">
            <a:solidFill>
              <a:srgbClr val="9966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037880" y="3419640"/>
            <a:ext cx="799884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0" lang="en-US" sz="1800" spc="-1" strike="noStrike">
                <a:solidFill>
                  <a:srgbClr val="9966cc"/>
                </a:solidFill>
                <a:latin typeface="Arial"/>
              </a:rPr>
              <a:t>RUGAUGA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                   </a:t>
            </a:r>
            <a:r>
              <a:rPr b="0" lang="en-US" sz="1800" spc="-1" strike="noStrike">
                <a:solidFill>
                  <a:srgbClr val="9966cc"/>
                </a:solidFill>
                <a:latin typeface="Arial"/>
              </a:rPr>
              <a:t>CUGA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0" lang="en-US" sz="1800" spc="-1" strike="noStrike">
                <a:solidFill>
                  <a:srgbClr val="9966cc"/>
                </a:solidFill>
                <a:latin typeface="Arial"/>
              </a:rPr>
              <a:t>UGAUGA                             CUG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079640" y="3419640"/>
            <a:ext cx="1260360" cy="360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816360" y="3419640"/>
            <a:ext cx="863640" cy="360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5400720" y="3419640"/>
            <a:ext cx="1081080" cy="360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8099280" y="3419640"/>
            <a:ext cx="900360" cy="360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7020000" y="3527280"/>
            <a:ext cx="1081080" cy="144720"/>
          </a:xfrm>
          <a:prstGeom prst="rect">
            <a:avLst/>
          </a:prstGeom>
          <a:solidFill>
            <a:srgbClr val="9966cc"/>
          </a:solidFill>
          <a:ln w="9360">
            <a:solidFill>
              <a:srgbClr val="9966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700360" y="3079800"/>
            <a:ext cx="1081080" cy="169920"/>
          </a:xfrm>
          <a:prstGeom prst="rect">
            <a:avLst/>
          </a:prstGeom>
          <a:solidFill>
            <a:srgbClr val="00ae00"/>
          </a:solidFill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701820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15320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728820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742320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55820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769320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782784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796284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809784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899400" y="2998800"/>
            <a:ext cx="131868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</a:rPr>
              <a:t>¤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6899400" y="3433680"/>
            <a:ext cx="131904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¤¤¤¤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69892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283356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296856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310356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323856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373560" y="328608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350820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64320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3778200" y="328608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577960" y="2998800"/>
            <a:ext cx="163368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</a:rPr>
              <a:t>¤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592360" y="3419640"/>
            <a:ext cx="14763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¤¤¤¤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>
            <a:off x="538200" y="3600360"/>
            <a:ext cx="542880" cy="1800"/>
          </a:xfrm>
          <a:prstGeom prst="line">
            <a:avLst/>
          </a:prstGeom>
          <a:ln w="36000">
            <a:solidFill>
              <a:srgbClr val="99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8999640" y="3600360"/>
            <a:ext cx="539640" cy="1800"/>
          </a:xfrm>
          <a:prstGeom prst="line">
            <a:avLst/>
          </a:prstGeom>
          <a:ln w="36000">
            <a:solidFill>
              <a:srgbClr val="99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4680000" y="3600360"/>
            <a:ext cx="720720" cy="1800"/>
          </a:xfrm>
          <a:prstGeom prst="line">
            <a:avLst/>
          </a:prstGeom>
          <a:ln w="36000">
            <a:solidFill>
              <a:srgbClr val="99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340000" y="3600360"/>
            <a:ext cx="360360" cy="1800"/>
          </a:xfrm>
          <a:prstGeom prst="line">
            <a:avLst/>
          </a:prstGeom>
          <a:ln w="36000">
            <a:solidFill>
              <a:srgbClr val="99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6480000" y="3600360"/>
            <a:ext cx="540000" cy="1800"/>
          </a:xfrm>
          <a:prstGeom prst="line">
            <a:avLst/>
          </a:prstGeom>
          <a:ln w="36000">
            <a:solidFill>
              <a:srgbClr val="99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09480" y="2252520"/>
            <a:ext cx="2071800" cy="879480"/>
          </a:xfrm>
          <a:custGeom>
            <a:avLst/>
            <a:gdLst/>
            <a:ahLst/>
            <a:rect l="l" t="t" r="r" b="b"/>
            <a:pathLst>
              <a:path w="5756" h="2445">
                <a:moveTo>
                  <a:pt x="0" y="180"/>
                </a:moveTo>
                <a:cubicBezTo>
                  <a:pt x="278" y="45"/>
                  <a:pt x="592" y="0"/>
                  <a:pt x="900" y="16"/>
                </a:cubicBezTo>
                <a:cubicBezTo>
                  <a:pt x="1226" y="33"/>
                  <a:pt x="1530" y="191"/>
                  <a:pt x="1773" y="398"/>
                </a:cubicBezTo>
                <a:cubicBezTo>
                  <a:pt x="2052" y="635"/>
                  <a:pt x="2260" y="958"/>
                  <a:pt x="2591" y="1134"/>
                </a:cubicBezTo>
                <a:cubicBezTo>
                  <a:pt x="2889" y="1293"/>
                  <a:pt x="3181" y="1465"/>
                  <a:pt x="3464" y="1653"/>
                </a:cubicBezTo>
                <a:cubicBezTo>
                  <a:pt x="3744" y="1839"/>
                  <a:pt x="4043" y="1946"/>
                  <a:pt x="4337" y="2089"/>
                </a:cubicBezTo>
                <a:cubicBezTo>
                  <a:pt x="4616" y="2225"/>
                  <a:pt x="4927" y="2293"/>
                  <a:pt x="5237" y="2334"/>
                </a:cubicBezTo>
                <a:lnTo>
                  <a:pt x="5537" y="2362"/>
                </a:lnTo>
                <a:lnTo>
                  <a:pt x="5755" y="2444"/>
                </a:lnTo>
              </a:path>
            </a:pathLst>
          </a:custGeom>
          <a:noFill/>
          <a:ln w="3600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3781440" y="1755720"/>
            <a:ext cx="3240000" cy="1433520"/>
          </a:xfrm>
          <a:custGeom>
            <a:avLst/>
            <a:gdLst/>
            <a:ahLst/>
            <a:rect l="l" t="t" r="r" b="b"/>
            <a:pathLst>
              <a:path w="9002" h="3982">
                <a:moveTo>
                  <a:pt x="0" y="3908"/>
                </a:moveTo>
                <a:cubicBezTo>
                  <a:pt x="318" y="3981"/>
                  <a:pt x="601" y="3785"/>
                  <a:pt x="873" y="3663"/>
                </a:cubicBezTo>
                <a:cubicBezTo>
                  <a:pt x="1214" y="3510"/>
                  <a:pt x="1431" y="3184"/>
                  <a:pt x="1691" y="2926"/>
                </a:cubicBezTo>
                <a:cubicBezTo>
                  <a:pt x="1946" y="2672"/>
                  <a:pt x="2069" y="2296"/>
                  <a:pt x="2400" y="2108"/>
                </a:cubicBezTo>
                <a:cubicBezTo>
                  <a:pt x="2654" y="1964"/>
                  <a:pt x="2944" y="1990"/>
                  <a:pt x="3219" y="1972"/>
                </a:cubicBezTo>
                <a:cubicBezTo>
                  <a:pt x="3561" y="1950"/>
                  <a:pt x="3879" y="2158"/>
                  <a:pt x="4037" y="2463"/>
                </a:cubicBezTo>
                <a:cubicBezTo>
                  <a:pt x="4190" y="2759"/>
                  <a:pt x="4309" y="3084"/>
                  <a:pt x="4528" y="3336"/>
                </a:cubicBezTo>
                <a:cubicBezTo>
                  <a:pt x="4780" y="3626"/>
                  <a:pt x="5146" y="3225"/>
                  <a:pt x="5292" y="2981"/>
                </a:cubicBezTo>
                <a:cubicBezTo>
                  <a:pt x="5462" y="2696"/>
                  <a:pt x="5654" y="2426"/>
                  <a:pt x="5810" y="2135"/>
                </a:cubicBezTo>
                <a:cubicBezTo>
                  <a:pt x="5971" y="1834"/>
                  <a:pt x="6102" y="1512"/>
                  <a:pt x="6301" y="1235"/>
                </a:cubicBezTo>
                <a:cubicBezTo>
                  <a:pt x="6542" y="899"/>
                  <a:pt x="6725" y="484"/>
                  <a:pt x="7092" y="281"/>
                </a:cubicBezTo>
                <a:cubicBezTo>
                  <a:pt x="7333" y="148"/>
                  <a:pt x="7755" y="0"/>
                  <a:pt x="7910" y="444"/>
                </a:cubicBezTo>
                <a:cubicBezTo>
                  <a:pt x="8009" y="726"/>
                  <a:pt x="7990" y="1011"/>
                  <a:pt x="7965" y="1290"/>
                </a:cubicBezTo>
                <a:cubicBezTo>
                  <a:pt x="7939" y="1585"/>
                  <a:pt x="7801" y="1861"/>
                  <a:pt x="7801" y="2163"/>
                </a:cubicBezTo>
                <a:cubicBezTo>
                  <a:pt x="7801" y="2456"/>
                  <a:pt x="7795" y="2760"/>
                  <a:pt x="7910" y="3036"/>
                </a:cubicBezTo>
                <a:cubicBezTo>
                  <a:pt x="8034" y="3334"/>
                  <a:pt x="8308" y="3604"/>
                  <a:pt x="8647" y="3636"/>
                </a:cubicBezTo>
                <a:lnTo>
                  <a:pt x="8947" y="3717"/>
                </a:lnTo>
                <a:lnTo>
                  <a:pt x="9001" y="3745"/>
                </a:lnTo>
              </a:path>
            </a:pathLst>
          </a:custGeom>
          <a:noFill/>
          <a:ln w="3600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8101080" y="1806480"/>
            <a:ext cx="1374840" cy="1390680"/>
          </a:xfrm>
          <a:custGeom>
            <a:avLst/>
            <a:gdLst/>
            <a:ahLst/>
            <a:rect l="l" t="t" r="r" b="b"/>
            <a:pathLst>
              <a:path w="3819" h="3864">
                <a:moveTo>
                  <a:pt x="0" y="3819"/>
                </a:moveTo>
                <a:cubicBezTo>
                  <a:pt x="298" y="3863"/>
                  <a:pt x="599" y="3852"/>
                  <a:pt x="900" y="3846"/>
                </a:cubicBezTo>
                <a:cubicBezTo>
                  <a:pt x="1199" y="3840"/>
                  <a:pt x="1535" y="3826"/>
                  <a:pt x="1773" y="3628"/>
                </a:cubicBezTo>
                <a:cubicBezTo>
                  <a:pt x="2041" y="3405"/>
                  <a:pt x="2274" y="3124"/>
                  <a:pt x="2400" y="2782"/>
                </a:cubicBezTo>
                <a:cubicBezTo>
                  <a:pt x="2509" y="2485"/>
                  <a:pt x="2570" y="2185"/>
                  <a:pt x="2645" y="1882"/>
                </a:cubicBezTo>
                <a:cubicBezTo>
                  <a:pt x="2720" y="1578"/>
                  <a:pt x="2818" y="1288"/>
                  <a:pt x="2946" y="1009"/>
                </a:cubicBezTo>
                <a:cubicBezTo>
                  <a:pt x="3095" y="685"/>
                  <a:pt x="3271" y="352"/>
                  <a:pt x="3573" y="137"/>
                </a:cubicBezTo>
                <a:lnTo>
                  <a:pt x="3818" y="0"/>
                </a:lnTo>
              </a:path>
            </a:pathLst>
          </a:custGeom>
          <a:noFill/>
          <a:ln w="36000">
            <a:solidFill>
              <a:srgbClr val="008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330920" y="3849840"/>
            <a:ext cx="6469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 bo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816360" y="3849840"/>
            <a:ext cx="6807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' bo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5616720" y="3849840"/>
            <a:ext cx="6807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C' bo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8279280" y="3849840"/>
            <a:ext cx="6469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 box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4683240" y="3670200"/>
            <a:ext cx="7171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pa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240120" y="367020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9360360" y="367020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518840" y="1979640"/>
            <a:ext cx="15951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US" sz="1400" spc="-1" strike="noStrike">
                <a:solidFill>
                  <a:srgbClr val="00ae00"/>
                </a:solidFill>
                <a:latin typeface="Arial"/>
              </a:rPr>
              <a:t>Target sequ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7199640" y="2340000"/>
            <a:ext cx="994680" cy="48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odifie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nucleo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7453440" y="2879640"/>
            <a:ext cx="179280" cy="179280"/>
            <a:chOff x="7453440" y="2879640"/>
            <a:chExt cx="179280" cy="179280"/>
          </a:xfrm>
        </p:grpSpPr>
        <p:sp>
          <p:nvSpPr>
            <p:cNvPr id="91" name=""/>
            <p:cNvSpPr/>
            <p:nvPr/>
          </p:nvSpPr>
          <p:spPr>
            <a:xfrm>
              <a:off x="7560360" y="2961720"/>
              <a:ext cx="1080" cy="97200"/>
            </a:xfrm>
            <a:prstGeom prst="line">
              <a:avLst/>
            </a:prstGeom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7453440" y="2879640"/>
              <a:ext cx="179280" cy="82080"/>
            </a:xfrm>
            <a:prstGeom prst="ellipse">
              <a:avLst/>
            </a:prstGeom>
            <a:solidFill>
              <a:srgbClr val="ff0000"/>
            </a:solidFill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11520" bIns="1152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3" name=""/>
          <p:cNvSpPr/>
          <p:nvPr/>
        </p:nvSpPr>
        <p:spPr>
          <a:xfrm>
            <a:off x="9239760" y="144000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59040" y="204948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2343240" y="3670200"/>
            <a:ext cx="7171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pa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6480360" y="3600360"/>
            <a:ext cx="7171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spacer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894960" y="4319640"/>
            <a:ext cx="225648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9966cc"/>
                </a:solidFill>
                <a:latin typeface="Arial"/>
              </a:rPr>
              <a:t>C/D box sRNA sequ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 flipH="1" rot="16200000">
            <a:off x="7326000" y="5236920"/>
            <a:ext cx="71640" cy="1332000"/>
          </a:xfrm>
          <a:custGeom>
            <a:avLst/>
            <a:gdLst>
              <a:gd name="textAreaLeft" fmla="*/ -360 w 71640"/>
              <a:gd name="textAreaRight" fmla="*/ 25560 w 71640"/>
              <a:gd name="textAreaTop" fmla="*/ 34560 h 1332000"/>
              <a:gd name="textAreaBottom" fmla="*/ 1297440 h 1332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5571000" y="6012000"/>
            <a:ext cx="336600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3fb52f"/>
                </a:solidFill>
                <a:latin typeface="Arial"/>
              </a:rPr>
              <a:t>Known region on the target sequ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4608360" y="4570560"/>
            <a:ext cx="4608720" cy="100944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5860080" y="4716360"/>
            <a:ext cx="22579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9933ff"/>
                </a:solidFill>
                <a:latin typeface="Arial"/>
              </a:rPr>
              <a:t>        </a:t>
            </a:r>
            <a:r>
              <a:rPr b="1" lang="en-US" sz="1400" spc="-1" strike="noStrike">
                <a:solidFill>
                  <a:srgbClr val="9933ff"/>
                </a:solidFill>
                <a:latin typeface="Arial"/>
              </a:rPr>
              <a:t>C/D motif searched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5214240" y="5148360"/>
            <a:ext cx="35319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UGAUGA</a:t>
            </a:r>
            <a:r>
              <a:rPr b="0" lang="en-US" sz="1800" spc="-1" strike="noStrike">
                <a:solidFill>
                  <a:srgbClr val="9966cc"/>
                </a:solidFill>
                <a:latin typeface="Arial"/>
              </a:rPr>
              <a:t>                             </a:t>
            </a: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CUG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 rot="10800000">
            <a:off x="6803640" y="5256000"/>
            <a:ext cx="1189080" cy="144360"/>
          </a:xfrm>
          <a:prstGeom prst="rect">
            <a:avLst/>
          </a:prstGeom>
          <a:solidFill>
            <a:srgbClr val="9966cc"/>
          </a:solidFill>
          <a:ln w="9360">
            <a:solidFill>
              <a:srgbClr val="9966cc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 flipH="1" flipV="1">
            <a:off x="6877080" y="547164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 flipH="1" flipV="1">
            <a:off x="7020000" y="547164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 flipH="1" flipV="1">
            <a:off x="7128000" y="547164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 flipH="1" flipV="1">
            <a:off x="7272360" y="547164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 flipH="1" flipV="1">
            <a:off x="7380360" y="547164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 flipH="1" flipV="1">
            <a:off x="7515360" y="5471640"/>
            <a:ext cx="144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 flipH="1" flipV="1">
            <a:off x="7649640" y="547164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 flipH="1" flipV="1">
            <a:off x="7784640" y="547164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 flipH="1" flipV="1">
            <a:off x="7919640" y="5471640"/>
            <a:ext cx="1800" cy="1494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6804000" y="5651640"/>
            <a:ext cx="1189080" cy="144360"/>
          </a:xfrm>
          <a:prstGeom prst="rect">
            <a:avLst/>
          </a:prstGeom>
          <a:solidFill>
            <a:srgbClr val="00ae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6735240" y="5543640"/>
            <a:ext cx="131868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</a:t>
            </a:r>
            <a:r>
              <a:rPr b="1" lang="en-US" sz="1800" spc="-1" strike="noStrike">
                <a:solidFill>
                  <a:srgbClr val="ff0000"/>
                </a:solidFill>
                <a:latin typeface="Arial"/>
              </a:rPr>
              <a:t>¤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6734880" y="5148360"/>
            <a:ext cx="131904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¤¤¤¤¤¤¤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227640" y="5327640"/>
            <a:ext cx="612720" cy="0"/>
          </a:xfrm>
          <a:prstGeom prst="line">
            <a:avLst/>
          </a:prstGeom>
          <a:ln w="36000">
            <a:solidFill>
              <a:srgbClr val="9966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181080" y="216000"/>
            <a:ext cx="33300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"/>
          <p:cNvSpPr/>
          <p:nvPr/>
        </p:nvSpPr>
        <p:spPr>
          <a:xfrm>
            <a:off x="5040360" y="755640"/>
            <a:ext cx="4032360" cy="5256360"/>
          </a:xfrm>
          <a:prstGeom prst="rect">
            <a:avLst/>
          </a:prstGeom>
          <a:solidFill>
            <a:srgbClr val="edfa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160720" y="1908000"/>
            <a:ext cx="1260360" cy="1081440"/>
          </a:xfrm>
          <a:custGeom>
            <a:avLst/>
            <a:gdLst/>
            <a:ahLst/>
            <a:rect l="l" t="t" r="r" b="b"/>
            <a:pathLst>
              <a:path w="3501" h="3001">
                <a:moveTo>
                  <a:pt x="0" y="1500"/>
                </a:moveTo>
                <a:lnTo>
                  <a:pt x="0" y="2500"/>
                </a:lnTo>
                <a:lnTo>
                  <a:pt x="0" y="3000"/>
                </a:lnTo>
                <a:lnTo>
                  <a:pt x="3000" y="3000"/>
                </a:lnTo>
                <a:lnTo>
                  <a:pt x="3000" y="2000"/>
                </a:lnTo>
                <a:lnTo>
                  <a:pt x="3500" y="2000"/>
                </a:lnTo>
                <a:lnTo>
                  <a:pt x="3500" y="1000"/>
                </a:lnTo>
                <a:lnTo>
                  <a:pt x="3000" y="1000"/>
                </a:lnTo>
                <a:lnTo>
                  <a:pt x="3000" y="0"/>
                </a:lnTo>
                <a:lnTo>
                  <a:pt x="2000" y="0"/>
                </a:lnTo>
                <a:lnTo>
                  <a:pt x="2000" y="1500"/>
                </a:lnTo>
                <a:lnTo>
                  <a:pt x="0" y="1500"/>
                </a:lnTo>
              </a:path>
            </a:pathLst>
          </a:custGeom>
          <a:solidFill>
            <a:srgbClr val="e6e6e6"/>
          </a:solidFill>
          <a:ln w="9360">
            <a:solidFill>
              <a:srgbClr val="e6e6e6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6372360" y="1835280"/>
            <a:ext cx="1116000" cy="612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200" spc="-1" strike="noStrike">
                <a:solidFill>
                  <a:srgbClr val="9966cc"/>
                </a:solidFill>
                <a:latin typeface="Arial"/>
              </a:rPr>
              <a:t>A             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72396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</a:tabLst>
            </a:pPr>
            <a:r>
              <a:rPr b="1" lang="en-US" sz="1200" spc="-1" strike="noStrike">
                <a:solidFill>
                  <a:srgbClr val="9966cc"/>
                </a:solidFill>
                <a:latin typeface="Arial"/>
              </a:rPr>
              <a:t>R             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3057480" y="2371680"/>
            <a:ext cx="32688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U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2844720" y="2124000"/>
            <a:ext cx="32688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R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2987640" y="6119640"/>
            <a:ext cx="432000" cy="180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419280" y="5940360"/>
            <a:ext cx="61956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AN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3456000" y="5975280"/>
            <a:ext cx="576360" cy="252360"/>
          </a:xfrm>
          <a:prstGeom prst="rect">
            <a:avLst/>
          </a:pr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727280" y="3924360"/>
            <a:ext cx="1873080" cy="863640"/>
          </a:xfrm>
          <a:prstGeom prst="ellipse">
            <a:avLst/>
          </a:prstGeom>
          <a:noFill/>
          <a:ln w="2844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2376360" y="3851280"/>
            <a:ext cx="574920" cy="325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2376360" y="4572000"/>
            <a:ext cx="574920" cy="325440"/>
          </a:xfrm>
          <a:prstGeom prst="rect">
            <a:avLst/>
          </a:prstGeom>
          <a:solidFill>
            <a:srgbClr val="ffffff"/>
          </a:solidFill>
          <a:ln w="9360">
            <a:solidFill>
              <a:srgbClr val="ffff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2376360" y="4716360"/>
            <a:ext cx="1800" cy="144000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2952720" y="4788000"/>
            <a:ext cx="19080" cy="133992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376360" y="3059280"/>
            <a:ext cx="1800" cy="90000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2930400" y="3075120"/>
            <a:ext cx="1800" cy="90000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3095640" y="385128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3311640" y="392436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3456000" y="414036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311640" y="435600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584360" y="414036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655640" y="435600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2378520" y="3959280"/>
            <a:ext cx="59076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en-GB" sz="1800" spc="-1" strike="noStrike">
                <a:solidFill>
                  <a:srgbClr val="3fb52f"/>
                </a:solidFill>
                <a:latin typeface="Arial"/>
              </a:rPr>
              <a:t>N </a:t>
            </a:r>
            <a:r>
              <a:rPr b="1" lang="en-GB" sz="1800" spc="-1" strike="noStrike">
                <a:solidFill>
                  <a:srgbClr val="ff0000"/>
                </a:solidFill>
                <a:latin typeface="Symbol"/>
                <a:ea typeface="Symbol"/>
              </a:rPr>
              <a:t>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584360" y="4140360"/>
            <a:ext cx="865080" cy="649080"/>
          </a:xfrm>
          <a:custGeom>
            <a:avLst/>
            <a:gdLst/>
            <a:ahLst/>
            <a:rect l="l" t="t" r="r" b="b"/>
            <a:pathLst>
              <a:path w="545" h="409">
                <a:moveTo>
                  <a:pt x="545" y="0"/>
                </a:moveTo>
                <a:cubicBezTo>
                  <a:pt x="413" y="42"/>
                  <a:pt x="281" y="84"/>
                  <a:pt x="273" y="137"/>
                </a:cubicBezTo>
                <a:cubicBezTo>
                  <a:pt x="265" y="190"/>
                  <a:pt x="544" y="273"/>
                  <a:pt x="499" y="318"/>
                </a:cubicBezTo>
                <a:cubicBezTo>
                  <a:pt x="454" y="363"/>
                  <a:pt x="83" y="394"/>
                  <a:pt x="0" y="409"/>
                </a:cubicBezTo>
              </a:path>
            </a:pathLst>
          </a:custGeom>
          <a:noFill/>
          <a:ln w="38160">
            <a:solidFill>
              <a:srgbClr val="3fb52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2689200" y="4140360"/>
            <a:ext cx="2206800" cy="718920"/>
          </a:xfrm>
          <a:custGeom>
            <a:avLst/>
            <a:gdLst/>
            <a:ahLst/>
            <a:rect l="l" t="t" r="r" b="b"/>
            <a:pathLst>
              <a:path w="1390" h="453">
                <a:moveTo>
                  <a:pt x="166" y="0"/>
                </a:moveTo>
                <a:cubicBezTo>
                  <a:pt x="279" y="23"/>
                  <a:pt x="392" y="46"/>
                  <a:pt x="392" y="91"/>
                </a:cubicBezTo>
                <a:cubicBezTo>
                  <a:pt x="392" y="136"/>
                  <a:pt x="0" y="212"/>
                  <a:pt x="166" y="272"/>
                </a:cubicBezTo>
                <a:cubicBezTo>
                  <a:pt x="332" y="332"/>
                  <a:pt x="861" y="392"/>
                  <a:pt x="1390" y="453"/>
                </a:cubicBezTo>
              </a:path>
            </a:pathLst>
          </a:custGeom>
          <a:noFill/>
          <a:ln w="38160">
            <a:solidFill>
              <a:srgbClr val="3fb52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431640" y="4788000"/>
            <a:ext cx="1224000" cy="792000"/>
          </a:xfrm>
          <a:custGeom>
            <a:avLst/>
            <a:gdLst/>
            <a:ahLst/>
            <a:rect l="l" t="t" r="r" b="b"/>
            <a:pathLst>
              <a:path w="771" h="499">
                <a:moveTo>
                  <a:pt x="771" y="0"/>
                </a:moveTo>
                <a:cubicBezTo>
                  <a:pt x="563" y="4"/>
                  <a:pt x="355" y="8"/>
                  <a:pt x="227" y="91"/>
                </a:cubicBezTo>
                <a:cubicBezTo>
                  <a:pt x="99" y="174"/>
                  <a:pt x="38" y="431"/>
                  <a:pt x="0" y="499"/>
                </a:cubicBezTo>
              </a:path>
            </a:pathLst>
          </a:custGeom>
          <a:noFill/>
          <a:ln w="38160">
            <a:solidFill>
              <a:srgbClr val="3fb52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160720" y="399564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1979640" y="406728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1871640" y="421164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2087640" y="435600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2879640" y="399564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095640" y="406728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3024360" y="421164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2736720" y="435600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2160720" y="4067280"/>
            <a:ext cx="71280" cy="36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1979640" y="4175280"/>
            <a:ext cx="73080" cy="36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836720" y="4319640"/>
            <a:ext cx="108000" cy="36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944720" y="4535640"/>
            <a:ext cx="144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 flipV="1">
            <a:off x="3095640" y="4066920"/>
            <a:ext cx="73080" cy="36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 flipV="1">
            <a:off x="3311640" y="4140000"/>
            <a:ext cx="73080" cy="3492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880" bIns="-1188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 flipV="1">
            <a:off x="3311640" y="4319280"/>
            <a:ext cx="180720" cy="36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440" bIns="-1044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024360" y="4535640"/>
            <a:ext cx="28728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1908000" y="385128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727280" y="395928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2484360" y="370836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2484360" y="388764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2484360" y="352728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2484360" y="334800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484360" y="316692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2519280" y="482436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2519280" y="500364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519280" y="518472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2519280" y="536400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2519280" y="554364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2519280" y="572436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2519280" y="590400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2519280" y="608472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-3600" y="4392720"/>
            <a:ext cx="15951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</a:tabLst>
            </a:pPr>
            <a:r>
              <a:rPr b="1" lang="en-US" sz="1400" spc="-1" strike="noStrike">
                <a:solidFill>
                  <a:srgbClr val="00ae00"/>
                </a:solidFill>
                <a:latin typeface="Arial"/>
              </a:rPr>
              <a:t>Target sequ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-1800" y="561672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4282920" y="485928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150560" y="597528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944720" y="6156360"/>
            <a:ext cx="431640" cy="144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4354200" y="5940360"/>
            <a:ext cx="6609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' en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4068720" y="6119640"/>
            <a:ext cx="250920" cy="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1725480" y="6480000"/>
            <a:ext cx="214668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9933ff"/>
                </a:solidFill>
                <a:latin typeface="Arial"/>
              </a:rPr>
              <a:t>H/ACA sRNA sequenc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7524720" y="5435640"/>
            <a:ext cx="637920" cy="259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9966cc"/>
                </a:solidFill>
                <a:latin typeface="Arial"/>
              </a:rPr>
              <a:t>   </a:t>
            </a:r>
            <a:r>
              <a:rPr b="1" lang="en-US" sz="1200" spc="-1" strike="noStrike">
                <a:solidFill>
                  <a:srgbClr val="9966cc"/>
                </a:solidFill>
                <a:latin typeface="Arial"/>
              </a:rPr>
              <a:t>A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6044760" y="863640"/>
            <a:ext cx="206136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  <a:tab algn="l" pos="9434520"/>
                <a:tab algn="l" pos="9883800"/>
                <a:tab algn="l" pos="10333080"/>
                <a:tab algn="l" pos="10782360"/>
              </a:tabLst>
            </a:pPr>
            <a:r>
              <a:rPr b="1" lang="en-US" sz="1400" spc="-1" strike="noStrike">
                <a:solidFill>
                  <a:srgbClr val="9933ff"/>
                </a:solidFill>
                <a:latin typeface="Arial"/>
              </a:rPr>
              <a:t>H/ACA motif searched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968040" y="2664000"/>
            <a:ext cx="1104120" cy="2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K-turn moti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6048360" y="2484360"/>
            <a:ext cx="593640" cy="684360"/>
          </a:xfrm>
          <a:custGeom>
            <a:avLst/>
            <a:gdLst/>
            <a:ahLst/>
            <a:rect l="l" t="t" r="r" b="b"/>
            <a:pathLst>
              <a:path w="374" h="431">
                <a:moveTo>
                  <a:pt x="374" y="431"/>
                </a:moveTo>
                <a:cubicBezTo>
                  <a:pt x="221" y="353"/>
                  <a:pt x="68" y="276"/>
                  <a:pt x="34" y="227"/>
                </a:cubicBezTo>
                <a:cubicBezTo>
                  <a:pt x="0" y="178"/>
                  <a:pt x="170" y="162"/>
                  <a:pt x="170" y="136"/>
                </a:cubicBezTo>
                <a:cubicBezTo>
                  <a:pt x="170" y="110"/>
                  <a:pt x="7" y="91"/>
                  <a:pt x="34" y="68"/>
                </a:cubicBezTo>
                <a:cubicBezTo>
                  <a:pt x="61" y="45"/>
                  <a:pt x="195" y="22"/>
                  <a:pt x="329" y="0"/>
                </a:cubicBezTo>
              </a:path>
            </a:pathLst>
          </a:custGeom>
          <a:noFill/>
          <a:ln w="28440">
            <a:solidFill>
              <a:srgbClr val="9933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7164360" y="2411280"/>
            <a:ext cx="436680" cy="792360"/>
          </a:xfrm>
          <a:custGeom>
            <a:avLst/>
            <a:gdLst/>
            <a:ahLst/>
            <a:rect l="l" t="t" r="r" b="b"/>
            <a:pathLst>
              <a:path w="275" h="499">
                <a:moveTo>
                  <a:pt x="64" y="0"/>
                </a:moveTo>
                <a:cubicBezTo>
                  <a:pt x="169" y="83"/>
                  <a:pt x="275" y="166"/>
                  <a:pt x="268" y="204"/>
                </a:cubicBezTo>
                <a:cubicBezTo>
                  <a:pt x="261" y="242"/>
                  <a:pt x="38" y="204"/>
                  <a:pt x="19" y="227"/>
                </a:cubicBezTo>
                <a:cubicBezTo>
                  <a:pt x="0" y="250"/>
                  <a:pt x="148" y="295"/>
                  <a:pt x="155" y="340"/>
                </a:cubicBezTo>
                <a:cubicBezTo>
                  <a:pt x="162" y="385"/>
                  <a:pt x="113" y="442"/>
                  <a:pt x="64" y="499"/>
                </a:cubicBezTo>
              </a:path>
            </a:pathLst>
          </a:custGeom>
          <a:noFill/>
          <a:ln w="28440">
            <a:solidFill>
              <a:srgbClr val="9933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7165800" y="1943280"/>
            <a:ext cx="2905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fr-FR" sz="1200" spc="-1" strike="noStrike">
                <a:solidFill>
                  <a:srgbClr val="9933ff"/>
                </a:solidFill>
                <a:latin typeface="Arial"/>
              </a:rPr>
              <a:t>U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7094520" y="1800360"/>
            <a:ext cx="29052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1" lang="fr-FR" sz="1200" spc="-1" strike="noStrike">
                <a:solidFill>
                  <a:srgbClr val="9933ff"/>
                </a:solidFill>
                <a:latin typeface="Arial"/>
              </a:rPr>
              <a:t>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2196360" y="2664000"/>
            <a:ext cx="33768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2737800" y="2411280"/>
            <a:ext cx="33768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771640" y="2664000"/>
            <a:ext cx="32688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2195640" y="2411280"/>
            <a:ext cx="326880" cy="316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9966cc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93" name=""/>
          <p:cNvGrpSpPr/>
          <p:nvPr/>
        </p:nvGrpSpPr>
        <p:grpSpPr>
          <a:xfrm>
            <a:off x="1511280" y="358920"/>
            <a:ext cx="2089080" cy="2054160"/>
            <a:chOff x="1511280" y="358920"/>
            <a:chExt cx="2089080" cy="2054160"/>
          </a:xfrm>
        </p:grpSpPr>
        <p:sp>
          <p:nvSpPr>
            <p:cNvPr id="194" name=""/>
            <p:cNvSpPr/>
            <p:nvPr/>
          </p:nvSpPr>
          <p:spPr>
            <a:xfrm>
              <a:off x="2904840" y="1617840"/>
              <a:ext cx="1440" cy="539640"/>
            </a:xfrm>
            <a:prstGeom prst="line">
              <a:avLst/>
            </a:prstGeom>
            <a:ln w="36000">
              <a:solidFill>
                <a:srgbClr val="9966cc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1511280" y="358920"/>
              <a:ext cx="2089080" cy="1260360"/>
            </a:xfrm>
            <a:prstGeom prst="ellipse">
              <a:avLst/>
            </a:prstGeom>
            <a:noFill/>
            <a:ln w="36000">
              <a:solidFill>
                <a:srgbClr val="9966cc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2376360" y="1474920"/>
              <a:ext cx="502920" cy="287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2376360" y="1617840"/>
              <a:ext cx="1080" cy="795240"/>
            </a:xfrm>
            <a:prstGeom prst="line">
              <a:avLst/>
            </a:prstGeom>
            <a:ln w="36000">
              <a:solidFill>
                <a:srgbClr val="9966cc"/>
              </a:solidFill>
              <a:prstDash val="sysDot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2484360" y="1978200"/>
              <a:ext cx="32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2484360" y="1725480"/>
              <a:ext cx="323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pPr>
                <a:lnSpc>
                  <a:spcPct val="93000"/>
                </a:lnSpc>
                <a:tabLst>
                  <a:tab algn="l" pos="0"/>
                  <a:tab algn="l" pos="449280"/>
                  <a:tab algn="l" pos="898560"/>
                  <a:tab algn="l" pos="1347840"/>
                  <a:tab algn="l" pos="1797120"/>
                  <a:tab algn="l" pos="2246400"/>
                  <a:tab algn="l" pos="2695680"/>
                  <a:tab algn="l" pos="3144960"/>
                  <a:tab algn="l" pos="3594240"/>
                  <a:tab algn="l" pos="4043520"/>
                  <a:tab algn="l" pos="4492800"/>
                  <a:tab algn="l" pos="4941720"/>
                  <a:tab algn="l" pos="5391000"/>
                  <a:tab algn="l" pos="5840280"/>
                  <a:tab algn="l" pos="6289560"/>
                  <a:tab algn="l" pos="6738840"/>
                  <a:tab algn="l" pos="7188120"/>
                  <a:tab algn="l" pos="7637400"/>
                  <a:tab algn="l" pos="8086680"/>
                  <a:tab algn="l" pos="8535960"/>
                  <a:tab algn="l" pos="898524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00" name=""/>
          <p:cNvSpPr/>
          <p:nvPr/>
        </p:nvSpPr>
        <p:spPr>
          <a:xfrm flipV="1">
            <a:off x="6624720" y="3156120"/>
            <a:ext cx="1440" cy="839520"/>
          </a:xfrm>
          <a:prstGeom prst="line">
            <a:avLst/>
          </a:prstGeom>
          <a:ln w="3816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 rot="16200000">
            <a:off x="6458040" y="3658680"/>
            <a:ext cx="3189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 rot="16200000">
            <a:off x="6458760" y="3478320"/>
            <a:ext cx="31752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 rot="16200000">
            <a:off x="6458760" y="3117960"/>
            <a:ext cx="31752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 rot="16200000">
            <a:off x="6458040" y="3298320"/>
            <a:ext cx="3189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6264360" y="1476360"/>
            <a:ext cx="1081080" cy="465120"/>
          </a:xfrm>
          <a:custGeom>
            <a:avLst/>
            <a:gdLst/>
            <a:ahLst/>
            <a:rect l="l" t="t" r="r" b="b"/>
            <a:pathLst>
              <a:path w="755" h="359">
                <a:moveTo>
                  <a:pt x="169" y="359"/>
                </a:moveTo>
                <a:cubicBezTo>
                  <a:pt x="84" y="315"/>
                  <a:pt x="0" y="272"/>
                  <a:pt x="11" y="246"/>
                </a:cubicBezTo>
                <a:cubicBezTo>
                  <a:pt x="22" y="220"/>
                  <a:pt x="218" y="235"/>
                  <a:pt x="237" y="201"/>
                </a:cubicBezTo>
                <a:cubicBezTo>
                  <a:pt x="256" y="167"/>
                  <a:pt x="64" y="72"/>
                  <a:pt x="124" y="42"/>
                </a:cubicBezTo>
                <a:cubicBezTo>
                  <a:pt x="184" y="12"/>
                  <a:pt x="543" y="0"/>
                  <a:pt x="600" y="19"/>
                </a:cubicBezTo>
                <a:cubicBezTo>
                  <a:pt x="657" y="38"/>
                  <a:pt x="441" y="125"/>
                  <a:pt x="464" y="155"/>
                </a:cubicBezTo>
                <a:cubicBezTo>
                  <a:pt x="487" y="185"/>
                  <a:pt x="717" y="175"/>
                  <a:pt x="736" y="201"/>
                </a:cubicBezTo>
                <a:cubicBezTo>
                  <a:pt x="755" y="227"/>
                  <a:pt x="666" y="270"/>
                  <a:pt x="578" y="314"/>
                </a:cubicBezTo>
              </a:path>
            </a:pathLst>
          </a:custGeom>
          <a:noFill/>
          <a:ln w="28440">
            <a:solidFill>
              <a:srgbClr val="9933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 flipV="1">
            <a:off x="7272360" y="3156120"/>
            <a:ext cx="1440" cy="876240"/>
          </a:xfrm>
          <a:prstGeom prst="line">
            <a:avLst/>
          </a:prstGeom>
          <a:ln w="3816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 rot="16200000">
            <a:off x="7111800" y="365292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 rot="16200000">
            <a:off x="7111440" y="347364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 rot="16200000">
            <a:off x="7111440" y="3113280"/>
            <a:ext cx="30816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 rot="16200000">
            <a:off x="7111800" y="3292560"/>
            <a:ext cx="307800" cy="345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¤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6804000" y="431964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6804000" y="450072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6804000" y="468000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6804000" y="485928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6804000" y="504036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6804000" y="521964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6732720" y="4248000"/>
            <a:ext cx="19080" cy="133992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7201080" y="4248000"/>
            <a:ext cx="18720" cy="133992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6804000" y="5400720"/>
            <a:ext cx="3240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6499080" y="3995640"/>
            <a:ext cx="233640" cy="289080"/>
          </a:xfrm>
          <a:custGeom>
            <a:avLst/>
            <a:gdLst/>
            <a:ahLst/>
            <a:rect l="l" t="t" r="r" b="b"/>
            <a:pathLst>
              <a:path w="147" h="182">
                <a:moveTo>
                  <a:pt x="79" y="0"/>
                </a:moveTo>
                <a:cubicBezTo>
                  <a:pt x="39" y="19"/>
                  <a:pt x="0" y="38"/>
                  <a:pt x="11" y="68"/>
                </a:cubicBezTo>
                <a:cubicBezTo>
                  <a:pt x="22" y="98"/>
                  <a:pt x="124" y="163"/>
                  <a:pt x="147" y="182"/>
                </a:cubicBezTo>
              </a:path>
            </a:pathLst>
          </a:custGeom>
          <a:noFill/>
          <a:ln w="28440">
            <a:solidFill>
              <a:srgbClr val="9933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7201080" y="3995640"/>
            <a:ext cx="226800" cy="289080"/>
          </a:xfrm>
          <a:custGeom>
            <a:avLst/>
            <a:gdLst/>
            <a:ahLst/>
            <a:rect l="l" t="t" r="r" b="b"/>
            <a:pathLst>
              <a:path w="143" h="182">
                <a:moveTo>
                  <a:pt x="45" y="0"/>
                </a:moveTo>
                <a:cubicBezTo>
                  <a:pt x="94" y="19"/>
                  <a:pt x="143" y="38"/>
                  <a:pt x="136" y="68"/>
                </a:cubicBezTo>
                <a:cubicBezTo>
                  <a:pt x="129" y="98"/>
                  <a:pt x="23" y="163"/>
                  <a:pt x="0" y="182"/>
                </a:cubicBezTo>
              </a:path>
            </a:pathLst>
          </a:custGeom>
          <a:noFill/>
          <a:ln w="28440">
            <a:solidFill>
              <a:srgbClr val="9933ff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7669080" y="2411280"/>
            <a:ext cx="0" cy="7923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7741800" y="2664000"/>
            <a:ext cx="5389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6-12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6335640" y="1800360"/>
            <a:ext cx="1081080" cy="610920"/>
          </a:xfrm>
          <a:custGeom>
            <a:avLst/>
            <a:gdLst/>
            <a:ahLst/>
            <a:rect l="l" t="t" r="r" b="b"/>
            <a:pathLst>
              <a:path w="681" h="385">
                <a:moveTo>
                  <a:pt x="0" y="136"/>
                </a:moveTo>
                <a:lnTo>
                  <a:pt x="0" y="385"/>
                </a:lnTo>
                <a:lnTo>
                  <a:pt x="590" y="385"/>
                </a:lnTo>
                <a:lnTo>
                  <a:pt x="590" y="249"/>
                </a:lnTo>
                <a:lnTo>
                  <a:pt x="681" y="249"/>
                </a:lnTo>
                <a:lnTo>
                  <a:pt x="681" y="0"/>
                </a:lnTo>
                <a:lnTo>
                  <a:pt x="499" y="0"/>
                </a:lnTo>
                <a:lnTo>
                  <a:pt x="499" y="136"/>
                </a:lnTo>
                <a:lnTo>
                  <a:pt x="0" y="136"/>
                </a:lnTo>
                <a:close/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7433280" y="1903320"/>
            <a:ext cx="596880" cy="263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200" spc="-1" strike="noStrike">
                <a:solidFill>
                  <a:srgbClr val="ffffff"/>
                </a:solidFill>
                <a:latin typeface="Arial"/>
              </a:rPr>
              <a:t>K-tur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6588000" y="4319640"/>
            <a:ext cx="0" cy="111600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7236000" y="5580000"/>
            <a:ext cx="431640" cy="1800"/>
          </a:xfrm>
          <a:prstGeom prst="line">
            <a:avLst/>
          </a:prstGeom>
          <a:ln w="36000">
            <a:solidFill>
              <a:srgbClr val="9933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7416720" y="3203640"/>
            <a:ext cx="0" cy="684000"/>
          </a:xfrm>
          <a:prstGeom prst="line">
            <a:avLst/>
          </a:prstGeom>
          <a:ln w="9360">
            <a:solidFill>
              <a:srgbClr val="52cd41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7455240" y="3419640"/>
            <a:ext cx="1480680" cy="37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3fb52f"/>
                </a:solidFill>
                <a:latin typeface="Arial"/>
              </a:rPr>
              <a:t>3-5 nt (complementar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3fb52f"/>
                </a:solidFill>
                <a:latin typeface="Arial"/>
              </a:rPr>
              <a:t>to the targe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6480000" y="3240000"/>
            <a:ext cx="0" cy="684360"/>
          </a:xfrm>
          <a:prstGeom prst="line">
            <a:avLst/>
          </a:prstGeom>
          <a:ln w="9360">
            <a:solidFill>
              <a:srgbClr val="52cd41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5005440" y="3384720"/>
            <a:ext cx="1480680" cy="37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3fb52f"/>
                </a:solidFill>
                <a:latin typeface="Arial"/>
              </a:rPr>
              <a:t>3-5 nt (complementary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3fb52f"/>
                </a:solidFill>
                <a:latin typeface="Arial"/>
              </a:rPr>
              <a:t>to the target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6012000" y="2484360"/>
            <a:ext cx="0" cy="79236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5365080" y="2735280"/>
            <a:ext cx="5389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6-12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6084720" y="1440000"/>
            <a:ext cx="1368720" cy="503280"/>
          </a:xfrm>
          <a:custGeom>
            <a:avLst/>
            <a:gdLst/>
            <a:ahLst/>
            <a:rect l="l" t="t" r="r" b="b"/>
            <a:pathLst>
              <a:path w="862" h="317">
                <a:moveTo>
                  <a:pt x="0" y="317"/>
                </a:moveTo>
                <a:lnTo>
                  <a:pt x="0" y="0"/>
                </a:lnTo>
                <a:lnTo>
                  <a:pt x="862" y="0"/>
                </a:lnTo>
                <a:lnTo>
                  <a:pt x="862" y="272"/>
                </a:lnTo>
              </a:path>
            </a:pathLst>
          </a:custGeom>
          <a:noFill/>
          <a:ln w="9360">
            <a:solidFill>
              <a:srgbClr val="000000"/>
            </a:solidFill>
            <a:round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6517800" y="1187280"/>
            <a:ext cx="57384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1-20 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7524720" y="3203640"/>
            <a:ext cx="108000" cy="2232000"/>
          </a:xfrm>
          <a:custGeom>
            <a:avLst/>
            <a:gdLst/>
            <a:ahLst/>
            <a:rect l="l" t="t" r="r" b="b"/>
            <a:pathLst>
              <a:path w="68" h="1406">
                <a:moveTo>
                  <a:pt x="0" y="0"/>
                </a:moveTo>
                <a:lnTo>
                  <a:pt x="0" y="1406"/>
                </a:lnTo>
                <a:lnTo>
                  <a:pt x="68" y="1406"/>
                </a:lnTo>
              </a:path>
            </a:pathLst>
          </a:custGeom>
          <a:noFill/>
          <a:ln w="9360">
            <a:solidFill>
              <a:srgbClr val="000000"/>
            </a:solidFill>
            <a:round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7454160" y="4967280"/>
            <a:ext cx="6091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13-16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5941800" y="4859280"/>
            <a:ext cx="50364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7-9p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7632720" y="3995640"/>
            <a:ext cx="0" cy="28908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7670520" y="4032360"/>
            <a:ext cx="4687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0-4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6013080" y="3995640"/>
            <a:ext cx="4687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0-4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7202160" y="5651640"/>
            <a:ext cx="468720" cy="235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000" spc="-1" strike="noStrike">
                <a:solidFill>
                  <a:srgbClr val="ffffff"/>
                </a:solidFill>
                <a:latin typeface="Arial"/>
              </a:rPr>
              <a:t>0-1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7236000" y="5651640"/>
            <a:ext cx="396720" cy="0"/>
          </a:xfrm>
          <a:prstGeom prst="line">
            <a:avLst/>
          </a:prstGeom>
          <a:ln w="9360">
            <a:solidFill>
              <a:srgbClr val="000000"/>
            </a:solidFill>
            <a:miter/>
            <a:headEnd len="med" type="arrow" w="med"/>
            <a:tailEnd len="med" type="arrow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125640" y="34920"/>
            <a:ext cx="333000" cy="348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93000"/>
              </a:lnSpc>
              <a:tabLst>
                <a:tab algn="l" pos="0"/>
                <a:tab algn="l" pos="449280"/>
                <a:tab algn="l" pos="898560"/>
                <a:tab algn="l" pos="1347840"/>
                <a:tab algn="l" pos="1797120"/>
                <a:tab algn="l" pos="2246400"/>
                <a:tab algn="l" pos="2695680"/>
                <a:tab algn="l" pos="3144960"/>
                <a:tab algn="l" pos="3594240"/>
                <a:tab algn="l" pos="4043520"/>
                <a:tab algn="l" pos="4492800"/>
                <a:tab algn="l" pos="4941720"/>
                <a:tab algn="l" pos="5391000"/>
                <a:tab algn="l" pos="5840280"/>
                <a:tab algn="l" pos="6289560"/>
                <a:tab algn="l" pos="6738840"/>
                <a:tab algn="l" pos="7188120"/>
                <a:tab algn="l" pos="7637400"/>
                <a:tab algn="l" pos="8086680"/>
                <a:tab algn="l" pos="8535960"/>
                <a:tab algn="l" pos="8985240"/>
              </a:tabLst>
            </a:pPr>
            <a:r>
              <a:rPr b="0" lang="fr-FR" sz="1800" spc="-1" strike="noStrike">
                <a:solidFill>
                  <a:srgbClr val="ffffff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Valerie de Crecy</cp:lastModifiedBy>
  <dcterms:modified xsi:type="dcterms:W3CDTF">2008-09-29T14:29:51Z</dcterms:modified>
  <cp:revision>9</cp:revision>
  <dc:subject/>
  <dc:title>Diapositive 1</dc:title>
</cp:coreProperties>
</file>